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6" r:id="rId2"/>
    <p:sldId id="277" r:id="rId3"/>
    <p:sldId id="284" r:id="rId4"/>
    <p:sldId id="290" r:id="rId5"/>
    <p:sldId id="291" r:id="rId6"/>
    <p:sldId id="292" r:id="rId7"/>
    <p:sldId id="285" r:id="rId8"/>
    <p:sldId id="293" r:id="rId9"/>
    <p:sldId id="287" r:id="rId10"/>
    <p:sldId id="288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36" autoAdjust="0"/>
    <p:restoredTop sz="71919" autoAdjust="0"/>
  </p:normalViewPr>
  <p:slideViewPr>
    <p:cSldViewPr snapToGrid="0">
      <p:cViewPr>
        <p:scale>
          <a:sx n="100" d="100"/>
          <a:sy n="100" d="100"/>
        </p:scale>
        <p:origin x="696" y="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4827D1-7AD3-4E88-A358-A6798AD58393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C88DB4-2A6E-42B1-BCC3-4EBEDE2DEB5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8026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50000"/>
              </a:lnSpc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1. Comparison of Scalp EEG (A) and SEEG (B) Seizure Pattern.</a:t>
            </a:r>
            <a:endParaRPr lang="fr-F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algn="just">
              <a:lnSpc>
                <a:spcPct val="150000"/>
              </a:lnSpc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nel A shows a scalp EEG seizure characterized by a right posterior temporal discharge with subsequent propagation to the entire right temporal lobe (high-pass filter: 0.3 s; low-pass filter: 70 Hz, length: 30 s, amplitude: 20 µV/mm).</a:t>
            </a:r>
            <a:endParaRPr lang="fr-F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C88DB4-2A6E-42B1-BCC3-4EBEDE2DEB54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1038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1. Comparison of Scalp EEG (A) and SEEG (B) Seizure Pattern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nel B displays SEEG findings marked by initial flattening and disappearance of interictal spikes, followed by a progressive build-up of low-voltage fast activity in the left parahippocampal gyrus, and later rhythmic theta activity involving both left and right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mporo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basal regions. (high-pass filter: 0.3 s; length: 30 s, amplitude: 50 µV/mm).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 3D representation of the SEEG electrodes and their spatial relationships is provided, alongside a visualization of th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ileptogenicity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dex (EI) across the electrodes is provided to help the understanding. A 3D representation of th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ileptogenicity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dex (EI) across electrode is provided.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EG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lectrode contacts are grouped into five anatomical groups: right mesial temporal region (TP2–TP3: temporal pole; A2–A3: anterior hippocampus; B1–B2: ventral diencephalon; C1–C2: posterior hippocampus), right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mporo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basal region (GPH1–GPH2 and GPH4–GPH5: parahippocampal cortex; GPH5–GPH6: collateral sulcus; GPH10–GPH11: anterior inferior temporal gyrus; GPH11–GPH12: anterior inferior temporal sulcus; OT2–OT3: lingual sulcus; OT8–OT9: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ccipito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temporal sulcus), right lateral temporal region (T4–T5: lateral anterior superior temporal gyrus; Ia1–Ia2: insula gyri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evi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, left mesial temporal region (B’3–B’4: anterior hippocampus; C’2–C’3: posterior hippocampus), and left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mporo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basal region (TB’1–TB’2: parahippocampal cortex; TB’5–TB’6: collateral sulcus; TB’9–TB’10: anterior inferior temporal gyrus; GPH’1–GPH’2: collateral sulcus; GPH’7–GPH’8: posterior inferior temporal gyrus; OT’2–OT’3: collateral sulcus; OT’7–OT’8: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ccipito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temporal sulcus).</a:t>
            </a:r>
            <a:endParaRPr lang="fr-F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C88DB4-2A6E-42B1-BCC3-4EBEDE2DEB54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6696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1576C64-D33D-4875-B15B-228CEFBE96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16C6523E-17EF-46C9-BF86-156230CDEE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CFB2AFA-C4D8-4765-B2E5-ABFBC2BED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AF08413-C71C-4AF7-BAF9-5870A3C15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946C0AB-215D-4BA6-BC08-1B600502A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364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E9F5230-EC24-4DBB-9563-9DB5B65E02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FB55CF2B-D7C1-4A31-BA7E-A3DCF81335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30B722E-F96C-423B-808C-29FA16990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A32C0F7-3EA5-4E97-939D-C7E0F905D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5AB3E83-3ED2-43CA-A9E7-614AF721E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436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E6A2AEE2-BB6F-41BE-B671-91C5DFA3E9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7FEBC65-9CD2-4627-8E7A-2720A584B8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684B67C-BBDF-49C2-A091-1442A8467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C89511D-4CDC-4C6A-A2AF-F6633BA91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2CE3787-2F9D-49B6-8BB7-A488CA8C2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76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82EC6C4-7FBE-42A2-B734-93DFEB011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A638551-11BA-4EB5-9E96-6168DBA519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193B23A-46A1-406E-A2AF-8A4B2BA49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51499FE-6A6C-4582-9C56-97D9D748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646AA1E-3717-41E1-A484-DE7085AAA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322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5F64FC0-9A2E-46D4-B7E0-05F894602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60DCBD9-9643-4C4E-9677-56E0C8A074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A78B851-02C1-4090-A082-A685751DD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C0047AC-A010-40BA-A187-6D6F505B8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1B46E82-7B89-4EF8-9D64-843A66666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403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9F6BF35-756B-484C-8B11-7BDD165DC3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A2D1C3C-7070-4932-8228-9808CD8B7F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2854B94D-0CB6-43DE-B2F8-8AD49E3C44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978ABD7-BF13-4ED1-818C-7FF2961D3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79E7F51-C22C-4329-88BE-06F827FB3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7EA249C-0FB6-424F-BD62-21CD5683E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39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699331E-5A70-4F63-A740-5226DEABA7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FB0BDA8-1BB0-4DD7-91AE-EADC457B35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B547E6A5-AE1F-4978-B903-9F2708B6A1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80248BFB-77F4-4973-83A4-25DC1C0607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4B7CA3D4-1FBD-48BA-BAE3-17B63DD8B7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21C03382-9714-4F2C-9F18-1B40257A6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AF34CB18-929B-4DCF-AEB6-21448397A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88AA2E40-5D07-4E35-A00E-4939D799D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816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6724C89-092F-4DFB-BD84-F157CAAAD4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0C0EE58E-3234-4FB0-BE57-F823E9646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5D2CBD56-EC62-4987-B5CB-67362BCA0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9AA09406-1DF3-4C2C-BB04-8EFB7E6F9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900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9CAA88CA-3BD1-4805-B105-640662AA3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5F8C8933-0304-4E72-9E11-C6C597717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D37D63E6-2250-450C-9E17-17D4B9B43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89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0C01CF4-5A5D-49DA-B5AC-A0257B4845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A00F8D6-2EE6-47FF-A9EB-34C915C6E2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42D3E31-7E06-4995-91A7-14CBE420A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3D75B8C-5211-40A7-B1C8-9BD953156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89E7157-FA15-4A4E-89FB-59CB881D1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BB2987C-CD51-4CA5-8A0F-3147D5D2C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58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D9951FC-5180-4D7F-825B-8B760A3BDF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448BB3D-F710-4624-A86F-7F0A7282E6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6ACD5C8-FC42-4335-BE62-7E75A70590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4F82B0A-E6FC-4EC6-A042-CAB72B691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7432FA7-C471-4914-A421-C1504DB34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F56C283-6E50-4BB8-9DF4-28F4F9A13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298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283CECF1-CADE-48BD-864E-12E0DFF199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1AA4DEB-A1A0-4BA6-BBCF-7EE25F0CF3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47CDF24-DD2C-46FE-B9F2-FDCFB9D539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A1D74-C884-4593-AB7D-CC45B69C1709}" type="datetimeFigureOut">
              <a:rPr lang="en-US" smtClean="0"/>
              <a:t>9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9488C3C-44BC-4F19-86A6-78CC169A5B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382FB53-8922-4D08-82D1-59D269B8A6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4FB9FE-3A98-436A-B65B-8155CB16A6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003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85A0C9F-0AC4-4612-87E6-6640752E60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1687032"/>
            <a:ext cx="12192000" cy="1127494"/>
          </a:xfrm>
        </p:spPr>
        <p:txBody>
          <a:bodyPr>
            <a:normAutofit fontScale="90000"/>
          </a:bodyPr>
          <a:lstStyle/>
          <a:p>
            <a:r>
              <a:rPr lang="en-US" sz="66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tfall of False </a:t>
            </a:r>
            <a:r>
              <a:rPr lang="en-US" sz="6600" dirty="0" err="1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calisation</a:t>
            </a:r>
            <a:r>
              <a:rPr lang="en-US" sz="66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Temporal Basal Epilepsy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xmlns="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xmlns="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xmlns="" id="{1337F9F9-8E94-4E18-CC41-8E5E553A559D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itle 1">
            <a:extLst>
              <a:ext uri="{FF2B5EF4-FFF2-40B4-BE49-F238E27FC236}">
                <a16:creationId xmlns:a16="http://schemas.microsoft.com/office/drawing/2014/main" xmlns="" id="{AF6877E5-15A1-EF06-6B68-5B78D5AB3E58}"/>
              </a:ext>
            </a:extLst>
          </p:cNvPr>
          <p:cNvSpPr txBox="1">
            <a:spLocks/>
          </p:cNvSpPr>
          <p:nvPr/>
        </p:nvSpPr>
        <p:spPr>
          <a:xfrm>
            <a:off x="0" y="3002857"/>
            <a:ext cx="12192000" cy="715107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70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000" i="1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thieu </a:t>
            </a:r>
            <a:r>
              <a:rPr lang="en-US" sz="4000" i="1" dirty="0" smtClean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hoisne, </a:t>
            </a:r>
            <a:r>
              <a:rPr lang="en-US" sz="4000" i="1" dirty="0" err="1" smtClean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main</a:t>
            </a:r>
            <a:r>
              <a:rPr lang="en-US" sz="4000" i="1" dirty="0" smtClean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arron</a:t>
            </a:r>
            <a:r>
              <a:rPr lang="en-US" sz="4000" i="1" dirty="0" smtClean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4000" i="1" dirty="0" err="1" smtClean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brice</a:t>
            </a:r>
            <a:r>
              <a:rPr lang="en-US" sz="4000" i="1" dirty="0" smtClean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4000" i="1" dirty="0" err="1" smtClean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rtolomei</a:t>
            </a:r>
            <a:r>
              <a:rPr lang="en-US" sz="4000" i="1" dirty="0" smtClean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4000" i="1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Stanislas Lagarde</a:t>
            </a:r>
            <a:endParaRPr lang="en-US" sz="3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5157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xmlns="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xmlns="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clus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xmlns="" id="{C118B30C-1AA3-2D80-0ACF-EF462D72F3C6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Anatomo-electro-clinical correlations are critical in identifying the epileptogenic zone and any discrepancies should raise suspicions and warrant further exploration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Any uncertainty when epilepsy surgery is being considered should be resolved through comprehensive investigations</a:t>
            </a:r>
          </a:p>
        </p:txBody>
      </p:sp>
    </p:spTree>
    <p:extLst>
      <p:ext uri="{BB962C8B-B14F-4D97-AF65-F5344CB8AC3E}">
        <p14:creationId xmlns:p14="http://schemas.microsoft.com/office/powerpoint/2010/main" val="33442019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xmlns="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xmlns="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xmlns="" id="{3B5767DF-6FC1-C095-64AF-60097645628C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alse lateralization of ictal EEG is an infrequent finding in temporal lobe epilepsy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Proposed explanations include: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Low-amplitude ictal discharges from cortical atrophy or cerebral damage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Severe hippocampal sclerosis (“burned-out” hippocampus)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Rapid contralateral spread through hippocampal commissures, anterior commissure or frontal limbic pathways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Coexistence of multiple epileptogenic foci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oduct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358421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xmlns="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xmlns="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xmlns="" id="{3B5767DF-6FC1-C095-64AF-60097645628C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21-year-old, right handed female, who experienced seizures characterized by isolated loss of responsiveness without any aura from 9 years-old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MRI revealed left parahippocampal gyrus </a:t>
            </a:r>
            <a:r>
              <a:rPr lang="en-US" sz="3200" dirty="0" err="1">
                <a:latin typeface="Arial" panose="020B0604020202020204" pitchFamily="34" charset="0"/>
                <a:cs typeface="Arial" panose="020B0604020202020204" pitchFamily="34" charset="0"/>
              </a:rPr>
              <a:t>cavernoma</a:t>
            </a:r>
            <a:endParaRPr 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Seizure frequency was not improved by its resection and seizure semiology evolved with a rising chest sensation, déjà vu, followed by a loss of responsiveness, chewing automatisms, and right-hand dystonia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Postictal aphasia was observe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Report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588066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xmlns="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xmlns="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xmlns="" id="{3B5767DF-6FC1-C095-64AF-60097645628C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fontScale="77500" lnSpcReduction="2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Interictal scalp EEG revealed: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Right anterior and middle temporal spikes and sharp waves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Rare left temporal anterior spikes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Ictal scalp EEG revealed: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First seizure: right posterior temporal discharge with subsequent spread to the entire temporal lobe (first seizure) (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Second seizure: no significant changes in background activit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Report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701242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xmlns="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xmlns="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xmlns="" id="{3B5767DF-6FC1-C095-64AF-60097645628C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fontScale="77500" lnSpcReduction="2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Interictal SEEG revealed: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Slowing of background activity in the left </a:t>
            </a:r>
            <a:r>
              <a:rPr lang="en-US" sz="2800" dirty="0" err="1">
                <a:latin typeface="Arial" panose="020B0604020202020204" pitchFamily="34" charset="0"/>
                <a:cs typeface="Arial" panose="020B0604020202020204" pitchFamily="34" charset="0"/>
              </a:rPr>
              <a:t>temporo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-basal region (within the resection cavity), right </a:t>
            </a:r>
            <a:r>
              <a:rPr lang="en-US" sz="2800" dirty="0" err="1">
                <a:latin typeface="Arial" panose="020B0604020202020204" pitchFamily="34" charset="0"/>
                <a:cs typeface="Arial" panose="020B0604020202020204" pitchFamily="34" charset="0"/>
              </a:rPr>
              <a:t>temporo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-basal area and right temporal pole 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Pseudoperiodic spikes and asymptomatic discharges in the left </a:t>
            </a:r>
            <a:r>
              <a:rPr lang="en-US" sz="2800" dirty="0" err="1">
                <a:latin typeface="Arial" panose="020B0604020202020204" pitchFamily="34" charset="0"/>
                <a:cs typeface="Arial" panose="020B0604020202020204" pitchFamily="34" charset="0"/>
              </a:rPr>
              <a:t>temporo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-basal region</a:t>
            </a:r>
          </a:p>
          <a:p>
            <a:pPr marL="914400" lvl="1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Spikes in the left entorhinal and parahippocampal gyri, as well as in right amygdala, hippocampus and parahippocampal gyru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Report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787367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xmlns="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xmlns="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7" name="Content Placeholder 2">
            <a:extLst>
              <a:ext uri="{FF2B5EF4-FFF2-40B4-BE49-F238E27FC236}">
                <a16:creationId xmlns:a16="http://schemas.microsoft.com/office/drawing/2014/main" xmlns="" id="{3B5767DF-6FC1-C095-64AF-60097645628C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1" indent="-457200" algn="just">
              <a:lnSpc>
                <a:spcPct val="20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Seizures exhibited a characteristic progression in SEEG 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marL="971550" lvl="1" indent="-514350" algn="just">
              <a:lnSpc>
                <a:spcPct val="200000"/>
              </a:lnSpc>
              <a:buFont typeface="+mj-lt"/>
              <a:buAutoNum type="arabicPeriod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Flattening and disappearance of the interictal spikes followed by low voltage fast activity in the left parahippocampal gyrus</a:t>
            </a:r>
          </a:p>
          <a:p>
            <a:pPr marL="971550" lvl="1" indent="-514350" algn="just">
              <a:lnSpc>
                <a:spcPct val="200000"/>
              </a:lnSpc>
              <a:buFont typeface="+mj-lt"/>
              <a:buAutoNum type="arabicPeriod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Rhythmic theta activity in both left and right </a:t>
            </a:r>
            <a:r>
              <a:rPr lang="en-US" sz="2800" dirty="0" err="1">
                <a:latin typeface="Arial" panose="020B0604020202020204" pitchFamily="34" charset="0"/>
                <a:cs typeface="Arial" panose="020B0604020202020204" pitchFamily="34" charset="0"/>
              </a:rPr>
              <a:t>temporo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-basal regions</a:t>
            </a:r>
          </a:p>
          <a:p>
            <a:pPr marL="971550" lvl="1" indent="-514350" algn="just">
              <a:lnSpc>
                <a:spcPct val="200000"/>
              </a:lnSpc>
              <a:buFont typeface="+mj-lt"/>
              <a:buAutoNum type="arabicPeriod"/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On the left: a sinusoidal alpha rhythm with superimposed fast activity followed by spike-wave discharges in the </a:t>
            </a:r>
            <a:r>
              <a:rPr lang="en-US" sz="2800" dirty="0" err="1">
                <a:latin typeface="Arial" panose="020B0604020202020204" pitchFamily="34" charset="0"/>
                <a:cs typeface="Arial" panose="020B0604020202020204" pitchFamily="34" charset="0"/>
              </a:rPr>
              <a:t>temporo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-basal area, propagating to the hippocampus</a:t>
            </a:r>
          </a:p>
          <a:p>
            <a:pPr lvl="1" algn="just">
              <a:lnSpc>
                <a:spcPct val="200000"/>
              </a:lnSpc>
            </a:pP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	On the right: a low-voltage fast activity in the </a:t>
            </a:r>
            <a:r>
              <a:rPr lang="en-US" sz="2800" dirty="0" err="1">
                <a:latin typeface="Arial" panose="020B0604020202020204" pitchFamily="34" charset="0"/>
                <a:cs typeface="Arial" panose="020B0604020202020204" pitchFamily="34" charset="0"/>
              </a:rPr>
              <a:t>temporo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-basal area, propagating to the 	amygdala, hippocampus and insul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Report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672183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xmlns="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xmlns="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Image 4">
            <a:extLst>
              <a:ext uri="{FF2B5EF4-FFF2-40B4-BE49-F238E27FC236}">
                <a16:creationId xmlns:a16="http://schemas.microsoft.com/office/drawing/2014/main" xmlns="" id="{7FB1762D-5821-493A-B991-2FDE2B86814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3" r="21571" b="50000"/>
          <a:stretch/>
        </p:blipFill>
        <p:spPr>
          <a:xfrm>
            <a:off x="723235" y="769441"/>
            <a:ext cx="10752304" cy="5211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63042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xmlns="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xmlns="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2" t="50613" r="1809"/>
          <a:stretch/>
        </p:blipFill>
        <p:spPr>
          <a:xfrm>
            <a:off x="8863" y="1726139"/>
            <a:ext cx="12169577" cy="3298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02733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clipart&#10;&#10;Description automatically generated">
            <a:extLst>
              <a:ext uri="{FF2B5EF4-FFF2-40B4-BE49-F238E27FC236}">
                <a16:creationId xmlns:a16="http://schemas.microsoft.com/office/drawing/2014/main" xmlns="" id="{18C5A51B-1E9E-2944-25C9-1C65590899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0" y="6156399"/>
            <a:ext cx="2342983" cy="594976"/>
          </a:xfrm>
          <a:prstGeom prst="rect">
            <a:avLst/>
          </a:prstGeom>
        </p:spPr>
      </p:pic>
      <p:pic>
        <p:nvPicPr>
          <p:cNvPr id="4" name="Picture 3" descr="A picture containing icon&#10;&#10;Description automatically generated">
            <a:extLst>
              <a:ext uri="{FF2B5EF4-FFF2-40B4-BE49-F238E27FC236}">
                <a16:creationId xmlns:a16="http://schemas.microsoft.com/office/drawing/2014/main" xmlns="" id="{FFE5E166-0B7C-0D56-6102-8620C6764D1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91521" y="6156398"/>
            <a:ext cx="1168036" cy="5949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89BECC9-AB5A-80A0-06E4-7A14F65C2C04}"/>
              </a:ext>
            </a:extLst>
          </p:cNvPr>
          <p:cNvSpPr txBox="1"/>
          <p:nvPr/>
        </p:nvSpPr>
        <p:spPr>
          <a:xfrm>
            <a:off x="88220" y="0"/>
            <a:ext cx="681765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cussio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D49817E1-9858-E40B-39FD-C6ACB2766262}"/>
              </a:ext>
            </a:extLst>
          </p:cNvPr>
          <p:cNvCxnSpPr/>
          <p:nvPr/>
        </p:nvCxnSpPr>
        <p:spPr>
          <a:xfrm>
            <a:off x="88220" y="5980854"/>
            <a:ext cx="11907353" cy="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xmlns="" id="{C118B30C-1AA3-2D80-0ACF-EF462D72F3C6}"/>
              </a:ext>
            </a:extLst>
          </p:cNvPr>
          <p:cNvSpPr txBox="1">
            <a:spLocks/>
          </p:cNvSpPr>
          <p:nvPr/>
        </p:nvSpPr>
        <p:spPr>
          <a:xfrm>
            <a:off x="88220" y="877145"/>
            <a:ext cx="11471156" cy="4880956"/>
          </a:xfrm>
          <a:prstGeom prst="rect">
            <a:avLst/>
          </a:prstGeom>
        </p:spPr>
        <p:txBody>
          <a:bodyPr vert="horz" lIns="91440" tIns="45720" rIns="91440" bIns="45720" rtlCol="0">
            <a:normAutofit fontScale="70000" lnSpcReduction="2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 err="1">
                <a:latin typeface="Arial" panose="020B0604020202020204" pitchFamily="34" charset="0"/>
                <a:cs typeface="Arial" panose="020B0604020202020204" pitchFamily="34" charset="0"/>
              </a:rPr>
              <a:t>Anatomoclinical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 data (with right-hand dystonia, postictal aphasia, and left-sided resection cavity) were discordant with electrical data (right-sided onset on scalp EEG)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Careful intracranial exploration revealed that the epileptogenic zone was located in the left </a:t>
            </a:r>
            <a:r>
              <a:rPr lang="en-US" sz="3200" dirty="0" err="1">
                <a:latin typeface="Arial" panose="020B0604020202020204" pitchFamily="34" charset="0"/>
                <a:cs typeface="Arial" panose="020B0604020202020204" pitchFamily="34" charset="0"/>
              </a:rPr>
              <a:t>temporo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-basal region with rapid propagation to the contralateral side and greater amplitude of seizure activity on the right side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alse lateralization was likely explained by these two factors combined with the resection cavity and deep, mesial nature of the generator</a:t>
            </a:r>
          </a:p>
          <a:p>
            <a:pPr marL="457200" indent="-457200" algn="just">
              <a:lnSpc>
                <a:spcPct val="200000"/>
              </a:lnSpc>
              <a:buFont typeface="Arial" panose="020B0604020202020204" pitchFamily="34" charset="0"/>
              <a:buChar char="•"/>
            </a:pPr>
            <a:endParaRPr 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1119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30</TotalTime>
  <Words>788</Words>
  <Application>Microsoft Office PowerPoint</Application>
  <PresentationFormat>Grand écran</PresentationFormat>
  <Paragraphs>51</Paragraphs>
  <Slides>10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itfall of False Localisation in Temporal Basal Epilepsy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minent ocular artifact from atypical ocular bobbing</dc:title>
  <dc:creator>Roohi Katyal</dc:creator>
  <cp:lastModifiedBy>mdhoisne</cp:lastModifiedBy>
  <cp:revision>74</cp:revision>
  <dcterms:created xsi:type="dcterms:W3CDTF">2021-09-03T02:53:53Z</dcterms:created>
  <dcterms:modified xsi:type="dcterms:W3CDTF">2025-09-24T16:46:42Z</dcterms:modified>
</cp:coreProperties>
</file>